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1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niel Kirouac" initials="DK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46"/>
    <a:srgbClr val="0000FF"/>
    <a:srgbClr val="FF0066"/>
    <a:srgbClr val="D9D9D9"/>
    <a:srgbClr val="FF0000"/>
    <a:srgbClr val="9BBB59"/>
    <a:srgbClr val="8064A2"/>
    <a:srgbClr val="C0504D"/>
    <a:srgbClr val="0000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290" autoAdjust="0"/>
  </p:normalViewPr>
  <p:slideViewPr>
    <p:cSldViewPr>
      <p:cViewPr>
        <p:scale>
          <a:sx n="140" d="100"/>
          <a:sy n="140" d="100"/>
        </p:scale>
        <p:origin x="-806" y="213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405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kirouac\Documents\Experimental%20Data%20-%20MM111\Dose%20Response%20Data\Jin\AKT%20x%20MEK%20inhibitor%20profiling\logic_modelPSO_Loop_Drug-Respons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kirouac\Documents\Experimental%20Data%20-%20MM111\Dose%20Response%20Data\Jin\AKT%20x%20MEK%20inhibitor%20profiling\logic_modelPSO_Loop_Drug-Response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57108486439195"/>
          <c:y val="5.1400554097404488E-2"/>
          <c:w val="0.82373359580052485"/>
          <c:h val="0.6094943861184019"/>
        </c:manualLayout>
      </c:layout>
      <c:barChart>
        <c:barDir val="col"/>
        <c:grouping val="clustered"/>
        <c:varyColors val="0"/>
        <c:ser>
          <c:idx val="0"/>
          <c:order val="0"/>
          <c:tx>
            <c:v>FBS</c:v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wAKTvERK!$C$1:$T$1</c:f>
              <c:strCache>
                <c:ptCount val="18"/>
                <c:pt idx="0">
                  <c:v>ZR7530</c:v>
                </c:pt>
                <c:pt idx="1">
                  <c:v>BT474-M3</c:v>
                </c:pt>
                <c:pt idx="2">
                  <c:v>HCC202</c:v>
                </c:pt>
                <c:pt idx="3">
                  <c:v>MDAMB361</c:v>
                </c:pt>
                <c:pt idx="4">
                  <c:v>MDAMB453</c:v>
                </c:pt>
                <c:pt idx="5">
                  <c:v>ZR751</c:v>
                </c:pt>
                <c:pt idx="6">
                  <c:v>AU565</c:v>
                </c:pt>
                <c:pt idx="7">
                  <c:v>SKBR3</c:v>
                </c:pt>
                <c:pt idx="8">
                  <c:v>HCC1419</c:v>
                </c:pt>
                <c:pt idx="9">
                  <c:v>HCC1954</c:v>
                </c:pt>
                <c:pt idx="10">
                  <c:v>MDAMB175VII</c:v>
                </c:pt>
                <c:pt idx="11">
                  <c:v>JIMT1</c:v>
                </c:pt>
                <c:pt idx="12">
                  <c:v>CALU3</c:v>
                </c:pt>
                <c:pt idx="13">
                  <c:v>SKOV3**</c:v>
                </c:pt>
                <c:pt idx="14">
                  <c:v>OE33</c:v>
                </c:pt>
                <c:pt idx="15">
                  <c:v>NCIN87</c:v>
                </c:pt>
                <c:pt idx="16">
                  <c:v>OE19</c:v>
                </c:pt>
                <c:pt idx="17">
                  <c:v>NCIH2170</c:v>
                </c:pt>
              </c:strCache>
            </c:strRef>
          </c:cat>
          <c:val>
            <c:numRef>
              <c:f>wAKTvERK!$C$2:$T$2</c:f>
              <c:numCache>
                <c:formatCode>General</c:formatCode>
                <c:ptCount val="18"/>
                <c:pt idx="0">
                  <c:v>1</c:v>
                </c:pt>
                <c:pt idx="1">
                  <c:v>0.991155765887478</c:v>
                </c:pt>
                <c:pt idx="2">
                  <c:v>0.98419962310824904</c:v>
                </c:pt>
                <c:pt idx="3">
                  <c:v>0.95798682461349105</c:v>
                </c:pt>
                <c:pt idx="4">
                  <c:v>0.99422902674945901</c:v>
                </c:pt>
                <c:pt idx="5">
                  <c:v>1</c:v>
                </c:pt>
                <c:pt idx="6">
                  <c:v>0.98250941743245201</c:v>
                </c:pt>
                <c:pt idx="7">
                  <c:v>0.99984126016136599</c:v>
                </c:pt>
                <c:pt idx="8">
                  <c:v>0.99370615315758604</c:v>
                </c:pt>
                <c:pt idx="9">
                  <c:v>4.7604436575773004E-3</c:v>
                </c:pt>
                <c:pt idx="10">
                  <c:v>8.9677628576307691E-3</c:v>
                </c:pt>
                <c:pt idx="11">
                  <c:v>2.21604177824378E-4</c:v>
                </c:pt>
                <c:pt idx="12">
                  <c:v>2.3805911330849702E-3</c:v>
                </c:pt>
                <c:pt idx="13">
                  <c:v>0.345914636597001</c:v>
                </c:pt>
                <c:pt idx="14">
                  <c:v>8.7639738007352003E-2</c:v>
                </c:pt>
                <c:pt idx="15">
                  <c:v>0.198933218651553</c:v>
                </c:pt>
                <c:pt idx="16">
                  <c:v>4.5516993645281098E-2</c:v>
                </c:pt>
                <c:pt idx="17">
                  <c:v>4.2904759784314302E-2</c:v>
                </c:pt>
              </c:numCache>
            </c:numRef>
          </c:val>
        </c:ser>
        <c:ser>
          <c:idx val="1"/>
          <c:order val="1"/>
          <c:tx>
            <c:v>HRG</c:v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wAKTvERK!$C$1:$T$1</c:f>
              <c:strCache>
                <c:ptCount val="18"/>
                <c:pt idx="0">
                  <c:v>ZR7530</c:v>
                </c:pt>
                <c:pt idx="1">
                  <c:v>BT474-M3</c:v>
                </c:pt>
                <c:pt idx="2">
                  <c:v>HCC202</c:v>
                </c:pt>
                <c:pt idx="3">
                  <c:v>MDAMB361</c:v>
                </c:pt>
                <c:pt idx="4">
                  <c:v>MDAMB453</c:v>
                </c:pt>
                <c:pt idx="5">
                  <c:v>ZR751</c:v>
                </c:pt>
                <c:pt idx="6">
                  <c:v>AU565</c:v>
                </c:pt>
                <c:pt idx="7">
                  <c:v>SKBR3</c:v>
                </c:pt>
                <c:pt idx="8">
                  <c:v>HCC1419</c:v>
                </c:pt>
                <c:pt idx="9">
                  <c:v>HCC1954</c:v>
                </c:pt>
                <c:pt idx="10">
                  <c:v>MDAMB175VII</c:v>
                </c:pt>
                <c:pt idx="11">
                  <c:v>JIMT1</c:v>
                </c:pt>
                <c:pt idx="12">
                  <c:v>CALU3</c:v>
                </c:pt>
                <c:pt idx="13">
                  <c:v>SKOV3**</c:v>
                </c:pt>
                <c:pt idx="14">
                  <c:v>OE33</c:v>
                </c:pt>
                <c:pt idx="15">
                  <c:v>NCIN87</c:v>
                </c:pt>
                <c:pt idx="16">
                  <c:v>OE19</c:v>
                </c:pt>
                <c:pt idx="17">
                  <c:v>NCIH2170</c:v>
                </c:pt>
              </c:strCache>
            </c:strRef>
          </c:cat>
          <c:val>
            <c:numRef>
              <c:f>wAKTvERK!$C$8:$T$8</c:f>
              <c:numCache>
                <c:formatCode>General</c:formatCode>
                <c:ptCount val="18"/>
                <c:pt idx="0">
                  <c:v>0.7197647114722</c:v>
                </c:pt>
                <c:pt idx="1">
                  <c:v>0.97674944115195905</c:v>
                </c:pt>
                <c:pt idx="2">
                  <c:v>0.99569618577637797</c:v>
                </c:pt>
                <c:pt idx="3">
                  <c:v>0.95468056436511906</c:v>
                </c:pt>
                <c:pt idx="4">
                  <c:v>0.99459523770804403</c:v>
                </c:pt>
                <c:pt idx="5">
                  <c:v>9.6855965628321204E-4</c:v>
                </c:pt>
                <c:pt idx="6">
                  <c:v>1E-4</c:v>
                </c:pt>
                <c:pt idx="7">
                  <c:v>5.7883424038852598E-2</c:v>
                </c:pt>
                <c:pt idx="8">
                  <c:v>0.14252411699547801</c:v>
                </c:pt>
                <c:pt idx="9">
                  <c:v>4.3197229900868002E-2</c:v>
                </c:pt>
                <c:pt idx="10">
                  <c:v>1.1991542012585199E-2</c:v>
                </c:pt>
                <c:pt idx="11">
                  <c:v>0.100816360666265</c:v>
                </c:pt>
                <c:pt idx="12">
                  <c:v>1.00014591697573E-4</c:v>
                </c:pt>
                <c:pt idx="13">
                  <c:v>9.9252952655575401E-3</c:v>
                </c:pt>
                <c:pt idx="14">
                  <c:v>5.3800864336836202E-2</c:v>
                </c:pt>
                <c:pt idx="15">
                  <c:v>4.1287171171889299E-2</c:v>
                </c:pt>
                <c:pt idx="16">
                  <c:v>2.2804702438655702E-2</c:v>
                </c:pt>
                <c:pt idx="17">
                  <c:v>1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14004864"/>
        <c:axId val="214006400"/>
      </c:barChart>
      <c:catAx>
        <c:axId val="214004864"/>
        <c:scaling>
          <c:orientation val="minMax"/>
        </c:scaling>
        <c:delete val="0"/>
        <c:axPos val="b"/>
        <c:majorTickMark val="none"/>
        <c:minorTickMark val="none"/>
        <c:tickLblPos val="low"/>
        <c:crossAx val="214006400"/>
        <c:crosses val="autoZero"/>
        <c:auto val="1"/>
        <c:lblAlgn val="ctr"/>
        <c:lblOffset val="100"/>
        <c:noMultiLvlLbl val="0"/>
      </c:catAx>
      <c:valAx>
        <c:axId val="214006400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w_AKT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0.3300251531058617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4004864"/>
        <c:crosses val="autoZero"/>
        <c:crossBetween val="between"/>
        <c:majorUnit val="0.5"/>
        <c:minorUnit val="0.1"/>
      </c:valAx>
      <c:spPr>
        <a:ln>
          <a:solidFill>
            <a:sysClr val="windowText" lastClr="000000"/>
          </a:solidFill>
        </a:ln>
      </c:spPr>
    </c:plotArea>
    <c:legend>
      <c:legendPos val="l"/>
      <c:layout>
        <c:manualLayout>
          <c:xMode val="edge"/>
          <c:yMode val="edge"/>
          <c:x val="0.83185651793525817"/>
          <c:y val="6.9060586176727903E-2"/>
          <c:w val="0.12858245844269467"/>
          <c:h val="0.16743438320209975"/>
        </c:manualLayout>
      </c:layout>
      <c:overlay val="1"/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22386264216973"/>
          <c:y val="5.1400554097404488E-2"/>
          <c:w val="0.82720581802274706"/>
          <c:h val="0.6094943861184019"/>
        </c:manualLayout>
      </c:layout>
      <c:barChart>
        <c:barDir val="col"/>
        <c:grouping val="clustered"/>
        <c:varyColors val="0"/>
        <c:ser>
          <c:idx val="0"/>
          <c:order val="0"/>
          <c:tx>
            <c:v>FBS</c:v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c:spPr>
          <c:invertIfNegative val="0"/>
          <c:cat>
            <c:strRef>
              <c:f>wAKTvERK!$C$1:$T$1</c:f>
              <c:strCache>
                <c:ptCount val="18"/>
                <c:pt idx="0">
                  <c:v>ZR7530</c:v>
                </c:pt>
                <c:pt idx="1">
                  <c:v>BT474-M3</c:v>
                </c:pt>
                <c:pt idx="2">
                  <c:v>HCC202</c:v>
                </c:pt>
                <c:pt idx="3">
                  <c:v>MDAMB361</c:v>
                </c:pt>
                <c:pt idx="4">
                  <c:v>MDAMB453</c:v>
                </c:pt>
                <c:pt idx="5">
                  <c:v>ZR751</c:v>
                </c:pt>
                <c:pt idx="6">
                  <c:v>AU565</c:v>
                </c:pt>
                <c:pt idx="7">
                  <c:v>SKBR3</c:v>
                </c:pt>
                <c:pt idx="8">
                  <c:v>HCC1419</c:v>
                </c:pt>
                <c:pt idx="9">
                  <c:v>HCC1954</c:v>
                </c:pt>
                <c:pt idx="10">
                  <c:v>MDAMB175VII</c:v>
                </c:pt>
                <c:pt idx="11">
                  <c:v>JIMT1</c:v>
                </c:pt>
                <c:pt idx="12">
                  <c:v>CALU3</c:v>
                </c:pt>
                <c:pt idx="13">
                  <c:v>SKOV3**</c:v>
                </c:pt>
                <c:pt idx="14">
                  <c:v>OE33</c:v>
                </c:pt>
                <c:pt idx="15">
                  <c:v>NCIN87</c:v>
                </c:pt>
                <c:pt idx="16">
                  <c:v>OE19</c:v>
                </c:pt>
                <c:pt idx="17">
                  <c:v>NCIH2170</c:v>
                </c:pt>
              </c:strCache>
            </c:strRef>
          </c:cat>
          <c:val>
            <c:numRef>
              <c:f>wAKTvERK!$C$3:$T$3</c:f>
              <c:numCache>
                <c:formatCode>General</c:formatCode>
                <c:ptCount val="18"/>
                <c:pt idx="0">
                  <c:v>1.02676471732279E-4</c:v>
                </c:pt>
                <c:pt idx="1">
                  <c:v>4.76916692180994E-3</c:v>
                </c:pt>
                <c:pt idx="2">
                  <c:v>3.9598936661581097E-2</c:v>
                </c:pt>
                <c:pt idx="3">
                  <c:v>1.4644401286021E-2</c:v>
                </c:pt>
                <c:pt idx="4">
                  <c:v>7.3308047643426202E-2</c:v>
                </c:pt>
                <c:pt idx="5">
                  <c:v>2.4960184216242302E-2</c:v>
                </c:pt>
                <c:pt idx="6">
                  <c:v>2.2903850683439399E-2</c:v>
                </c:pt>
                <c:pt idx="7">
                  <c:v>6.0232977364059803E-2</c:v>
                </c:pt>
                <c:pt idx="8">
                  <c:v>6.3537695481778095E-2</c:v>
                </c:pt>
                <c:pt idx="9">
                  <c:v>9.3341166131313505E-2</c:v>
                </c:pt>
                <c:pt idx="10">
                  <c:v>0.10705531203747699</c:v>
                </c:pt>
                <c:pt idx="11">
                  <c:v>0.47543724286994998</c:v>
                </c:pt>
                <c:pt idx="12">
                  <c:v>0.53461894131459498</c:v>
                </c:pt>
                <c:pt idx="13">
                  <c:v>0.91884362122533703</c:v>
                </c:pt>
                <c:pt idx="14">
                  <c:v>0.72034291683121399</c:v>
                </c:pt>
                <c:pt idx="15">
                  <c:v>0.91414770930064504</c:v>
                </c:pt>
                <c:pt idx="16">
                  <c:v>0.82092262628618795</c:v>
                </c:pt>
                <c:pt idx="17">
                  <c:v>0.84030681387985795</c:v>
                </c:pt>
              </c:numCache>
            </c:numRef>
          </c:val>
        </c:ser>
        <c:ser>
          <c:idx val="1"/>
          <c:order val="1"/>
          <c:tx>
            <c:v>HRG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c:spPr>
          <c:invertIfNegative val="0"/>
          <c:cat>
            <c:strRef>
              <c:f>wAKTvERK!$C$1:$T$1</c:f>
              <c:strCache>
                <c:ptCount val="18"/>
                <c:pt idx="0">
                  <c:v>ZR7530</c:v>
                </c:pt>
                <c:pt idx="1">
                  <c:v>BT474-M3</c:v>
                </c:pt>
                <c:pt idx="2">
                  <c:v>HCC202</c:v>
                </c:pt>
                <c:pt idx="3">
                  <c:v>MDAMB361</c:v>
                </c:pt>
                <c:pt idx="4">
                  <c:v>MDAMB453</c:v>
                </c:pt>
                <c:pt idx="5">
                  <c:v>ZR751</c:v>
                </c:pt>
                <c:pt idx="6">
                  <c:v>AU565</c:v>
                </c:pt>
                <c:pt idx="7">
                  <c:v>SKBR3</c:v>
                </c:pt>
                <c:pt idx="8">
                  <c:v>HCC1419</c:v>
                </c:pt>
                <c:pt idx="9">
                  <c:v>HCC1954</c:v>
                </c:pt>
                <c:pt idx="10">
                  <c:v>MDAMB175VII</c:v>
                </c:pt>
                <c:pt idx="11">
                  <c:v>JIMT1</c:v>
                </c:pt>
                <c:pt idx="12">
                  <c:v>CALU3</c:v>
                </c:pt>
                <c:pt idx="13">
                  <c:v>SKOV3**</c:v>
                </c:pt>
                <c:pt idx="14">
                  <c:v>OE33</c:v>
                </c:pt>
                <c:pt idx="15">
                  <c:v>NCIN87</c:v>
                </c:pt>
                <c:pt idx="16">
                  <c:v>OE19</c:v>
                </c:pt>
                <c:pt idx="17">
                  <c:v>NCIH2170</c:v>
                </c:pt>
              </c:strCache>
            </c:strRef>
          </c:cat>
          <c:val>
            <c:numRef>
              <c:f>wAKTvERK!$C$9:$T$9</c:f>
              <c:numCache>
                <c:formatCode>General</c:formatCode>
                <c:ptCount val="18"/>
                <c:pt idx="0">
                  <c:v>6.0845234549263601E-3</c:v>
                </c:pt>
                <c:pt idx="1">
                  <c:v>2.16399718968307E-3</c:v>
                </c:pt>
                <c:pt idx="2">
                  <c:v>0.116887177630493</c:v>
                </c:pt>
                <c:pt idx="3">
                  <c:v>1.2510373942422299E-4</c:v>
                </c:pt>
                <c:pt idx="4">
                  <c:v>0.15266842718336901</c:v>
                </c:pt>
                <c:pt idx="5">
                  <c:v>0.75337790291621398</c:v>
                </c:pt>
                <c:pt idx="6">
                  <c:v>0.68101930675310496</c:v>
                </c:pt>
                <c:pt idx="7">
                  <c:v>0.56951853758682303</c:v>
                </c:pt>
                <c:pt idx="8">
                  <c:v>0.92330751700938196</c:v>
                </c:pt>
                <c:pt idx="9">
                  <c:v>0.79230801746330404</c:v>
                </c:pt>
                <c:pt idx="10">
                  <c:v>0.18785648798535201</c:v>
                </c:pt>
                <c:pt idx="11">
                  <c:v>0.97069632847354403</c:v>
                </c:pt>
                <c:pt idx="12">
                  <c:v>0.99624574380528996</c:v>
                </c:pt>
                <c:pt idx="13">
                  <c:v>3.9977139993950202E-2</c:v>
                </c:pt>
                <c:pt idx="14">
                  <c:v>0.68569428177874303</c:v>
                </c:pt>
                <c:pt idx="15">
                  <c:v>0.69633321005101501</c:v>
                </c:pt>
                <c:pt idx="16">
                  <c:v>0.99169127108399402</c:v>
                </c:pt>
                <c:pt idx="17">
                  <c:v>0.85639345691341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14089728"/>
        <c:axId val="214091264"/>
      </c:barChart>
      <c:catAx>
        <c:axId val="214089728"/>
        <c:scaling>
          <c:orientation val="minMax"/>
        </c:scaling>
        <c:delete val="0"/>
        <c:axPos val="b"/>
        <c:majorTickMark val="none"/>
        <c:minorTickMark val="none"/>
        <c:tickLblPos val="low"/>
        <c:crossAx val="214091264"/>
        <c:crosses val="autoZero"/>
        <c:auto val="1"/>
        <c:lblAlgn val="ctr"/>
        <c:lblOffset val="100"/>
        <c:noMultiLvlLbl val="0"/>
      </c:catAx>
      <c:valAx>
        <c:axId val="21409126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w_ERK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0.2976177456984543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4089728"/>
        <c:crosses val="autoZero"/>
        <c:crossBetween val="between"/>
        <c:majorUnit val="0.5"/>
        <c:minorUnit val="0.1"/>
      </c:valAx>
      <c:spPr>
        <a:ln>
          <a:solidFill>
            <a:sysClr val="windowText" lastClr="000000"/>
          </a:solidFill>
        </a:ln>
      </c:spPr>
    </c:plotArea>
    <c:legend>
      <c:legendPos val="l"/>
      <c:layout>
        <c:manualLayout>
          <c:xMode val="edge"/>
          <c:yMode val="edge"/>
          <c:x val="0.12352318460192478"/>
          <c:y val="5.5171697287839022E-2"/>
          <c:w val="0.12858245844269467"/>
          <c:h val="0.16743438320209975"/>
        </c:manualLayout>
      </c:layout>
      <c:overlay val="1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697462817147857"/>
          <c:y val="5.0925925925925923E-2"/>
          <c:w val="0.81134492563429572"/>
          <c:h val="0.7951079031787693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V_all!$AP$2:$AP$11</c:f>
                <c:numCache>
                  <c:formatCode>General</c:formatCode>
                  <c:ptCount val="10"/>
                  <c:pt idx="0">
                    <c:v>0.25885843620817889</c:v>
                  </c:pt>
                  <c:pt idx="1">
                    <c:v>0.67413255009775586</c:v>
                  </c:pt>
                  <c:pt idx="2">
                    <c:v>10.346046690498511</c:v>
                  </c:pt>
                  <c:pt idx="3">
                    <c:v>24.85999150948162</c:v>
                  </c:pt>
                  <c:pt idx="4">
                    <c:v>45.358675992876449</c:v>
                  </c:pt>
                  <c:pt idx="5">
                    <c:v>19.040216471637606</c:v>
                  </c:pt>
                  <c:pt idx="6">
                    <c:v>27.505057749398016</c:v>
                  </c:pt>
                  <c:pt idx="7">
                    <c:v>38.162707847353218</c:v>
                  </c:pt>
                  <c:pt idx="8">
                    <c:v>127.09068708668441</c:v>
                  </c:pt>
                  <c:pt idx="9">
                    <c:v>138.8230463178806</c:v>
                  </c:pt>
                </c:numCache>
              </c:numRef>
            </c:plus>
            <c:minus>
              <c:numRef>
                <c:f>CV_all!$AP$2:$AP$11</c:f>
                <c:numCache>
                  <c:formatCode>General</c:formatCode>
                  <c:ptCount val="10"/>
                  <c:pt idx="0">
                    <c:v>0.25885843620817889</c:v>
                  </c:pt>
                  <c:pt idx="1">
                    <c:v>0.67413255009775586</c:v>
                  </c:pt>
                  <c:pt idx="2">
                    <c:v>10.346046690498511</c:v>
                  </c:pt>
                  <c:pt idx="3">
                    <c:v>24.85999150948162</c:v>
                  </c:pt>
                  <c:pt idx="4">
                    <c:v>45.358675992876449</c:v>
                  </c:pt>
                  <c:pt idx="5">
                    <c:v>19.040216471637606</c:v>
                  </c:pt>
                  <c:pt idx="6">
                    <c:v>27.505057749398016</c:v>
                  </c:pt>
                  <c:pt idx="7">
                    <c:v>38.162707847353218</c:v>
                  </c:pt>
                  <c:pt idx="8">
                    <c:v>127.09068708668441</c:v>
                  </c:pt>
                  <c:pt idx="9">
                    <c:v>138.8230463178806</c:v>
                  </c:pt>
                </c:numCache>
              </c:numRef>
            </c:minus>
          </c:errBars>
          <c:cat>
            <c:strRef>
              <c:f>CV_all!$A$2:$A$11</c:f>
              <c:strCache>
                <c:ptCount val="10"/>
                <c:pt idx="0">
                  <c:v>AIC</c:v>
                </c:pt>
                <c:pt idx="1">
                  <c:v>MSE</c:v>
                </c:pt>
                <c:pt idx="2">
                  <c:v>Umax</c:v>
                </c:pt>
                <c:pt idx="3">
                  <c:v>BIAS</c:v>
                </c:pt>
                <c:pt idx="4">
                  <c:v>U/Dmax</c:v>
                </c:pt>
                <c:pt idx="5">
                  <c:v>Dmax</c:v>
                </c:pt>
                <c:pt idx="6">
                  <c:v>wERK</c:v>
                </c:pt>
                <c:pt idx="7">
                  <c:v>K</c:v>
                </c:pt>
                <c:pt idx="8">
                  <c:v>wAKT</c:v>
                </c:pt>
                <c:pt idx="9">
                  <c:v>TAU</c:v>
                </c:pt>
              </c:strCache>
            </c:strRef>
          </c:cat>
          <c:val>
            <c:numRef>
              <c:f>CV_all!$AO$2:$AO$11</c:f>
              <c:numCache>
                <c:formatCode>General</c:formatCode>
                <c:ptCount val="10"/>
                <c:pt idx="0">
                  <c:v>0.18477192390221742</c:v>
                </c:pt>
                <c:pt idx="1">
                  <c:v>0.9338686579858837</c:v>
                </c:pt>
                <c:pt idx="2">
                  <c:v>0.79048114884167942</c:v>
                </c:pt>
                <c:pt idx="3">
                  <c:v>3.7403885023991026</c:v>
                </c:pt>
                <c:pt idx="4">
                  <c:v>14.240505196772201</c:v>
                </c:pt>
                <c:pt idx="5">
                  <c:v>22.765853942739561</c:v>
                </c:pt>
                <c:pt idx="6">
                  <c:v>21.704653371110393</c:v>
                </c:pt>
                <c:pt idx="7">
                  <c:v>16.079691559828788</c:v>
                </c:pt>
                <c:pt idx="8">
                  <c:v>24.406564068282965</c:v>
                </c:pt>
                <c:pt idx="9">
                  <c:v>75.7658747064506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14201856"/>
        <c:axId val="214203392"/>
      </c:barChart>
      <c:catAx>
        <c:axId val="214201856"/>
        <c:scaling>
          <c:orientation val="minMax"/>
        </c:scaling>
        <c:delete val="0"/>
        <c:axPos val="l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14203392"/>
        <c:crosses val="autoZero"/>
        <c:auto val="1"/>
        <c:lblAlgn val="ctr"/>
        <c:lblOffset val="100"/>
        <c:noMultiLvlLbl val="0"/>
      </c:catAx>
      <c:valAx>
        <c:axId val="214203392"/>
        <c:scaling>
          <c:orientation val="minMax"/>
          <c:max val="1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%CV Parameter Estimate</a:t>
                </a:r>
              </a:p>
            </c:rich>
          </c:tx>
          <c:layout>
            <c:manualLayout>
              <c:xMode val="edge"/>
              <c:yMode val="edge"/>
              <c:x val="0.37150131233595796"/>
              <c:y val="0.9296062992125984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1420185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A969B1C-6080-4F80-AD60-AF0D6D3C6D3E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4D1A1FA-BB6C-4C7B-B716-7471FC4FE1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086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6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436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22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49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6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960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381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24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344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71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630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162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3253347"/>
              </p:ext>
            </p:extLst>
          </p:nvPr>
        </p:nvGraphicFramePr>
        <p:xfrm>
          <a:off x="381000" y="533400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975640"/>
              </p:ext>
            </p:extLst>
          </p:nvPr>
        </p:nvGraphicFramePr>
        <p:xfrm>
          <a:off x="381000" y="3288983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0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5 Figure </a:t>
            </a:r>
            <a:endParaRPr lang="en-US" sz="1200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377929"/>
              </p:ext>
            </p:extLst>
          </p:nvPr>
        </p:nvGraphicFramePr>
        <p:xfrm>
          <a:off x="762000" y="59436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0" y="429399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0" y="3048000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0" y="5819001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C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64012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045</TotalTime>
  <Words>1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rrimack Pharmaceutical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Kirouac</dc:creator>
  <cp:lastModifiedBy>Jinyan Du</cp:lastModifiedBy>
  <cp:revision>390</cp:revision>
  <cp:lastPrinted>2014-06-20T13:57:28Z</cp:lastPrinted>
  <dcterms:created xsi:type="dcterms:W3CDTF">2013-12-19T16:18:28Z</dcterms:created>
  <dcterms:modified xsi:type="dcterms:W3CDTF">2016-03-10T23:17:34Z</dcterms:modified>
</cp:coreProperties>
</file>